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61A6ED-6643-4547-AE96-79710BA64D4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276F4E-0801-4ABD-BCC7-4ED6FFF3995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FF9B11-1214-461E-83A1-6E500D94A14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E9F05E-46A7-45E1-86E5-60197B5297D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F4AB0D-27EA-4E3C-8C2E-FC8258A270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084727-0F3E-403F-9297-78CA5EBA2B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636612-0629-4088-8F67-06511A710C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8D52E6-FD9F-4BAA-80E8-160D5417AB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6CA345-7E22-42EA-B418-4B8262E136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094A50-44C1-46EA-AB89-6EAB567440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98E5AC-1C36-4B73-8188-5FFEEC6BF2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1681F0-D7DF-4177-8FBD-F39F7A325B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F181C3F-24AD-408C-8DA9-268E1D173B71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3.png"/><Relationship Id="rId8" Type="http://schemas.openxmlformats.org/officeDocument/2006/relationships/image" Target="../media/image3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4737960" y="44280"/>
            <a:ext cx="429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gata </a:t>
            </a:r>
            <a:r>
              <a:rPr b="1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et al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., Supplementary Figure S6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図 3" descr=""/>
          <p:cNvPicPr/>
          <p:nvPr/>
        </p:nvPicPr>
        <p:blipFill>
          <a:blip r:embed="rId1"/>
          <a:stretch/>
        </p:blipFill>
        <p:spPr>
          <a:xfrm>
            <a:off x="2771640" y="3951360"/>
            <a:ext cx="2808360" cy="39528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43" name="図 4" descr=""/>
          <p:cNvPicPr/>
          <p:nvPr/>
        </p:nvPicPr>
        <p:blipFill>
          <a:blip r:embed="rId2"/>
          <a:srcRect l="14563" t="42912" r="57876" b="48821"/>
          <a:stretch/>
        </p:blipFill>
        <p:spPr>
          <a:xfrm>
            <a:off x="2771640" y="4454640"/>
            <a:ext cx="2808360" cy="39672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sp>
        <p:nvSpPr>
          <p:cNvPr id="44" name="テキスト ボックス 14"/>
          <p:cNvSpPr/>
          <p:nvPr/>
        </p:nvSpPr>
        <p:spPr>
          <a:xfrm>
            <a:off x="6033960" y="4114800"/>
            <a:ext cx="91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UNX2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5" name="Picture 15" descr=""/>
          <p:cNvPicPr/>
          <p:nvPr/>
        </p:nvPicPr>
        <p:blipFill>
          <a:blip r:embed="rId3"/>
          <a:stretch/>
        </p:blipFill>
        <p:spPr>
          <a:xfrm>
            <a:off x="5554800" y="4133880"/>
            <a:ext cx="480960" cy="264960"/>
          </a:xfrm>
          <a:prstGeom prst="rect">
            <a:avLst/>
          </a:prstGeom>
          <a:ln w="0">
            <a:noFill/>
          </a:ln>
        </p:spPr>
      </p:pic>
      <p:sp>
        <p:nvSpPr>
          <p:cNvPr id="46" name="テキスト ボックス 20"/>
          <p:cNvSpPr/>
          <p:nvPr/>
        </p:nvSpPr>
        <p:spPr>
          <a:xfrm>
            <a:off x="6033960" y="4448160"/>
            <a:ext cx="91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ctin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7" name="Picture 15" descr=""/>
          <p:cNvPicPr/>
          <p:nvPr/>
        </p:nvPicPr>
        <p:blipFill>
          <a:blip r:embed="rId4"/>
          <a:stretch/>
        </p:blipFill>
        <p:spPr>
          <a:xfrm>
            <a:off x="5554800" y="4484520"/>
            <a:ext cx="480960" cy="265320"/>
          </a:xfrm>
          <a:prstGeom prst="rect">
            <a:avLst/>
          </a:prstGeom>
          <a:ln w="0">
            <a:noFill/>
          </a:ln>
        </p:spPr>
      </p:pic>
      <p:sp>
        <p:nvSpPr>
          <p:cNvPr id="48" name="テキスト ボックス 8"/>
          <p:cNvSpPr/>
          <p:nvPr/>
        </p:nvSpPr>
        <p:spPr>
          <a:xfrm rot="19493400">
            <a:off x="2778120" y="2176200"/>
            <a:ext cx="1739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ontrol siRN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テキスト ボックス 9"/>
          <p:cNvSpPr/>
          <p:nvPr/>
        </p:nvSpPr>
        <p:spPr>
          <a:xfrm rot="19493400">
            <a:off x="3558600" y="2182680"/>
            <a:ext cx="1552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UNX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siRNA-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テキスト ボックス 10"/>
          <p:cNvSpPr/>
          <p:nvPr/>
        </p:nvSpPr>
        <p:spPr>
          <a:xfrm rot="19493400">
            <a:off x="4222080" y="2182680"/>
            <a:ext cx="1550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UNX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siRNA-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テキスト ボックス 11"/>
          <p:cNvSpPr/>
          <p:nvPr/>
        </p:nvSpPr>
        <p:spPr>
          <a:xfrm rot="19493400">
            <a:off x="4938840" y="2172960"/>
            <a:ext cx="1589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UNX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siRNA-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" name="図 12" descr=""/>
          <p:cNvPicPr/>
          <p:nvPr/>
        </p:nvPicPr>
        <p:blipFill>
          <a:blip r:embed="rId5"/>
          <a:srcRect l="23958" t="10100" r="38509" b="84654"/>
          <a:stretch/>
        </p:blipFill>
        <p:spPr>
          <a:xfrm>
            <a:off x="2771640" y="2943360"/>
            <a:ext cx="2808360" cy="395280"/>
          </a:xfrm>
          <a:prstGeom prst="rect">
            <a:avLst/>
          </a:prstGeom>
          <a:ln w="0">
            <a:noFill/>
          </a:ln>
        </p:spPr>
      </p:pic>
      <p:pic>
        <p:nvPicPr>
          <p:cNvPr id="53" name="図 13" descr=""/>
          <p:cNvPicPr/>
          <p:nvPr/>
        </p:nvPicPr>
        <p:blipFill>
          <a:blip r:embed="rId6"/>
          <a:stretch/>
        </p:blipFill>
        <p:spPr>
          <a:xfrm>
            <a:off x="2771640" y="3392640"/>
            <a:ext cx="2808360" cy="395280"/>
          </a:xfrm>
          <a:prstGeom prst="rect">
            <a:avLst/>
          </a:prstGeom>
          <a:ln w="0">
            <a:noFill/>
          </a:ln>
        </p:spPr>
      </p:pic>
      <p:sp>
        <p:nvSpPr>
          <p:cNvPr id="54" name="テキスト ボックス 14"/>
          <p:cNvSpPr/>
          <p:nvPr/>
        </p:nvSpPr>
        <p:spPr>
          <a:xfrm>
            <a:off x="6033960" y="3068640"/>
            <a:ext cx="91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RUNX2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5" name="Picture 15" descr=""/>
          <p:cNvPicPr/>
          <p:nvPr/>
        </p:nvPicPr>
        <p:blipFill>
          <a:blip r:embed="rId7"/>
          <a:stretch/>
        </p:blipFill>
        <p:spPr>
          <a:xfrm>
            <a:off x="5554800" y="3087720"/>
            <a:ext cx="480960" cy="264960"/>
          </a:xfrm>
          <a:prstGeom prst="rect">
            <a:avLst/>
          </a:prstGeom>
          <a:ln w="0">
            <a:noFill/>
          </a:ln>
        </p:spPr>
      </p:pic>
      <p:sp>
        <p:nvSpPr>
          <p:cNvPr id="56" name="テキスト ボックス 20"/>
          <p:cNvSpPr/>
          <p:nvPr/>
        </p:nvSpPr>
        <p:spPr>
          <a:xfrm>
            <a:off x="6033960" y="3402000"/>
            <a:ext cx="91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GAPDH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7" name="Picture 15" descr=""/>
          <p:cNvPicPr/>
          <p:nvPr/>
        </p:nvPicPr>
        <p:blipFill>
          <a:blip r:embed="rId8"/>
          <a:stretch/>
        </p:blipFill>
        <p:spPr>
          <a:xfrm>
            <a:off x="5554800" y="3438360"/>
            <a:ext cx="480960" cy="265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2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8-25T01:06:46Z</dcterms:created>
  <dc:creator>kouji</dc:creator>
  <dc:description/>
  <dc:language>en-US</dc:language>
  <cp:lastModifiedBy>尾崎 俊文</cp:lastModifiedBy>
  <cp:lastPrinted>2015-09-02T09:42:29Z</cp:lastPrinted>
  <dcterms:modified xsi:type="dcterms:W3CDTF">2017-06-09T07:31:04Z</dcterms:modified>
  <cp:revision>702</cp:revision>
  <dc:subject/>
  <dc:title>SAHA induces cell death of p53-mutated human pancreatic cancer MiaPaCa-2 cells through the up-regulation of TAp63  Takehiro Ogata, Mizuyo Nakamura, Osamu Shimozato, Toshinori Ozaki</dc:title>
</cp:coreProperties>
</file>